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FE7A88-CC4E-4FAB-A2C8-0F37002B9974}" v="2" dt="2023-06-08T00:27:06.5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44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ll, Caroline (H&amp;B, Adelaide K. Ave)" userId="4b594580-8786-4667-9eef-5568800c44e0" providerId="ADAL" clId="{0EFE7A88-CC4E-4FAB-A2C8-0F37002B9974}"/>
    <pc:docChg chg="undo custSel modSld">
      <pc:chgData name="Bull, Caroline (H&amp;B, Adelaide K. Ave)" userId="4b594580-8786-4667-9eef-5568800c44e0" providerId="ADAL" clId="{0EFE7A88-CC4E-4FAB-A2C8-0F37002B9974}" dt="2023-06-08T00:27:34.334" v="144" actId="1035"/>
      <pc:docMkLst>
        <pc:docMk/>
      </pc:docMkLst>
      <pc:sldChg chg="addSp delSp modSp mod">
        <pc:chgData name="Bull, Caroline (H&amp;B, Adelaide K. Ave)" userId="4b594580-8786-4667-9eef-5568800c44e0" providerId="ADAL" clId="{0EFE7A88-CC4E-4FAB-A2C8-0F37002B9974}" dt="2023-06-08T00:27:34.334" v="144" actId="1035"/>
        <pc:sldMkLst>
          <pc:docMk/>
          <pc:sldMk cId="1401231975" sldId="256"/>
        </pc:sldMkLst>
        <pc:spChg chg="add mod">
          <ac:chgData name="Bull, Caroline (H&amp;B, Adelaide K. Ave)" userId="4b594580-8786-4667-9eef-5568800c44e0" providerId="ADAL" clId="{0EFE7A88-CC4E-4FAB-A2C8-0F37002B9974}" dt="2023-06-08T00:27:25.645" v="69" actId="1076"/>
          <ac:spMkLst>
            <pc:docMk/>
            <pc:sldMk cId="1401231975" sldId="256"/>
            <ac:spMk id="2" creationId="{CC2E54ED-3784-4679-5904-B9B9EF89FD46}"/>
          </ac:spMkLst>
        </pc:spChg>
        <pc:spChg chg="add mod">
          <ac:chgData name="Bull, Caroline (H&amp;B, Adelaide K. Ave)" userId="4b594580-8786-4667-9eef-5568800c44e0" providerId="ADAL" clId="{0EFE7A88-CC4E-4FAB-A2C8-0F37002B9974}" dt="2023-06-08T00:27:34.334" v="144" actId="1035"/>
          <ac:spMkLst>
            <pc:docMk/>
            <pc:sldMk cId="1401231975" sldId="256"/>
            <ac:spMk id="3" creationId="{B58734AE-F170-B649-E9B3-38D14827BE8C}"/>
          </ac:spMkLst>
        </pc:spChg>
        <pc:grpChg chg="mod">
          <ac:chgData name="Bull, Caroline (H&amp;B, Adelaide K. Ave)" userId="4b594580-8786-4667-9eef-5568800c44e0" providerId="ADAL" clId="{0EFE7A88-CC4E-4FAB-A2C8-0F37002B9974}" dt="2023-06-08T00:27:34.334" v="144" actId="1035"/>
          <ac:grpSpMkLst>
            <pc:docMk/>
            <pc:sldMk cId="1401231975" sldId="256"/>
            <ac:grpSpMk id="7" creationId="{DCCFE4FE-8F79-4917-B28C-E3B6A5C1A6BC}"/>
          </ac:grpSpMkLst>
        </pc:grpChg>
        <pc:graphicFrameChg chg="add del mod">
          <ac:chgData name="Bull, Caroline (H&amp;B, Adelaide K. Ave)" userId="4b594580-8786-4667-9eef-5568800c44e0" providerId="ADAL" clId="{0EFE7A88-CC4E-4FAB-A2C8-0F37002B9974}" dt="2023-06-08T00:27:10.182" v="52" actId="478"/>
          <ac:graphicFrameMkLst>
            <pc:docMk/>
            <pc:sldMk cId="1401231975" sldId="256"/>
            <ac:graphicFrameMk id="8" creationId="{15EA23CD-2F71-F11E-477B-1DA1A7D13A44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8A176F-2B3A-47CB-8E79-76C8E14E22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76461D-7238-43DC-8E70-1E22A7271A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02DF6-49FA-42B6-922B-AEA7078B4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57DCF0-A385-40E6-B66C-13A2C82FA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4410BF-9EE2-4981-ACFD-DA81E03FA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2056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7ED97-A701-4E72-B783-AFDA52BE05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23D753-C84B-48A8-9759-D46AF25C54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0C6F3F-7CD6-44C2-8F44-DAA21B95D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BFF51B-7B01-424E-95CA-7DB9B7716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216433-DEAA-4AF0-9B43-5CC58F341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447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9C61B5-8972-4AB2-9AE4-484FA2940D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CDEDFF-6D9D-4893-8E14-8748D8A8AA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F8BBB-E20E-4E5A-9BDA-EFA7818F3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ADB68-5E52-4791-860D-4C01782ED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44281-9D0B-41BA-ACE0-56570C73F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21288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A8F4E-4782-456E-AD15-FCFAA4D19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3DE740-BB09-4A11-A858-CE6B05860B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F56914-115C-44B6-A00C-4F3E22A08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5036B6-6B6F-4922-A850-3806DEE80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49EDF1-D90C-4AF1-80A9-A640A28C5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3032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09374-42FE-4D4B-8C98-D2B5BB634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FD7DC0-AD3C-47DB-9A45-E7B2226373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5A614D-F060-4375-90AD-27971B549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7A33DC-4FC4-403B-A342-30468F08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2B32AA-6BE7-47D1-A27E-D1D630251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10387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AB63BF-AFCA-4F92-B74F-DE1B419FC8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0BD072-DC3B-477F-9E8A-DB59CEAE78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9B53F6-6757-45DB-A024-74E30CEEAF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F98905-F059-415D-94BA-4E336A3B4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74F770-15F6-4957-88D5-470689210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2E8CF-F308-4E52-A052-9D35ADB7C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09965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F01C1-B5D8-45F7-B707-9773D7B95A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4D1F40-2F78-4E51-90DD-8C1DCBCA36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4D2C8F-72CF-454B-9B78-F0632C2880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8E929D-0479-42D3-BA5E-FB9BA92F93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81CD6A-B981-43B7-99EF-A1D684BD6C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E706C0-DD3F-4241-92E5-0A9A932F7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76017C-199D-46B4-A900-9BA7D2421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BA75F3-50BB-4A83-A4D5-669E22890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2511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30A20-37A1-4E79-A90C-09828C48F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7D9CE2-F84A-4A4C-AB77-0928E408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E90932-6114-4122-8441-37D2FF50D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9CCD48-069D-4E7E-93DD-6958B069F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50411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4FA47B-B470-425F-ABBF-D3781E018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792E97-53F9-477C-8501-0EE0378E7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630F8A-8B4F-4C24-9724-F70CA2135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1555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A3B25-69FB-4EE6-B642-888C519A4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4C4F39-0A88-4348-8347-4900398474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5DE432-2F9C-4C96-A148-552A3F655E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218377-4DBA-4C9F-96BB-20F93B36E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BDFAB8-32C3-4ACD-9BFC-AA5BC791A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5B44D9-BC77-44DB-92A9-451E7CF2F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7332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41067-AA3E-4364-9597-C3EA417D9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7BB740-250E-41C6-9E85-13FC4EEC25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8AA49D-4474-4B86-8EFB-3557B358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BC4AC5-EF20-4C90-B8F9-6859125FE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279618-1F4F-485B-ADBF-D6C6909B0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08ED3-8BCA-485E-A8A8-458F0FAA3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2379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611990-F9B9-45FF-9C76-6CEB7DB80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927881-5D6D-4CA1-8F16-3D7C1EE42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CBA19C-3584-4D4A-9ACE-0744536902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BDD90-723B-4A46-9296-24FF46665E24}" type="datetimeFigureOut">
              <a:rPr lang="en-AU" smtClean="0"/>
              <a:t>8/06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832C6-AEDE-4F74-8633-0BF2AA991C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49F1FD-CB87-4BD3-8F53-70CF2764B2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FD6C8-CD38-4404-84A8-26C02FEE40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2728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DCCFE4FE-8F79-4917-B28C-E3B6A5C1A6BC}"/>
              </a:ext>
            </a:extLst>
          </p:cNvPr>
          <p:cNvGrpSpPr/>
          <p:nvPr/>
        </p:nvGrpSpPr>
        <p:grpSpPr>
          <a:xfrm>
            <a:off x="3323371" y="744135"/>
            <a:ext cx="3070225" cy="5768975"/>
            <a:chOff x="3310759" y="441435"/>
            <a:chExt cx="3070225" cy="5768975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2168A743-8709-41DF-B09F-6622EE56A65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79636144"/>
                </p:ext>
              </p:extLst>
            </p:nvPr>
          </p:nvGraphicFramePr>
          <p:xfrm>
            <a:off x="3310759" y="441435"/>
            <a:ext cx="3070225" cy="2835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4656195" imgH="4324166" progId="Prism9.Document">
                    <p:embed/>
                  </p:oleObj>
                </mc:Choice>
                <mc:Fallback>
                  <p:oleObj name="Prism 9" r:id="rId2" imgW="4656195" imgH="4324166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2168A743-8709-41DF-B09F-6622EE56A65B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10759" y="441435"/>
                          <a:ext cx="3070225" cy="283527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44624B00-7D65-4F65-B2B7-BDB87479E0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9439010"/>
                </p:ext>
              </p:extLst>
            </p:nvPr>
          </p:nvGraphicFramePr>
          <p:xfrm>
            <a:off x="3310759" y="3276710"/>
            <a:ext cx="2971800" cy="2933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4157407" imgH="4126140" progId="Prism9.Document">
                    <p:embed/>
                  </p:oleObj>
                </mc:Choice>
                <mc:Fallback>
                  <p:oleObj name="Prism 9" r:id="rId4" imgW="4157407" imgH="4126140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44624B00-7D65-4F65-B2B7-BDB87479E05C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10759" y="3276710"/>
                          <a:ext cx="2971800" cy="29337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Rectangle 3">
            <a:extLst>
              <a:ext uri="{FF2B5EF4-FFF2-40B4-BE49-F238E27FC236}">
                <a16:creationId xmlns:a16="http://schemas.microsoft.com/office/drawing/2014/main" id="{7F76879B-9774-48DB-9415-E7C17C4974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0759" y="44143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8734AE-F170-B649-E9B3-38D14827BE8C}"/>
              </a:ext>
            </a:extLst>
          </p:cNvPr>
          <p:cNvSpPr txBox="1"/>
          <p:nvPr/>
        </p:nvSpPr>
        <p:spPr>
          <a:xfrm>
            <a:off x="6837133" y="2325669"/>
            <a:ext cx="3404147" cy="28152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AU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Effect of single vitamins relative to multivitamin interventions on micronuclei (MN) </a:t>
            </a: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b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] lymphocytes </a:t>
            </a: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b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] buccal cells</a:t>
            </a: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>
              <a:lnSpc>
                <a:spcPct val="200000"/>
              </a:lnSpc>
            </a:pPr>
            <a:r>
              <a:rPr lang="en-US" sz="10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error bars are the mean of multiple studies while those without error bars are the results from single studies.</a:t>
            </a:r>
            <a:endParaRPr lang="en-AU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AU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AU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2E54ED-3784-4679-5904-B9B9EF89FD46}"/>
              </a:ext>
            </a:extLst>
          </p:cNvPr>
          <p:cNvSpPr txBox="1"/>
          <p:nvPr/>
        </p:nvSpPr>
        <p:spPr>
          <a:xfrm>
            <a:off x="119746" y="66610"/>
            <a:ext cx="6563720" cy="404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  Fenech et al “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tective effects of nutrients against DNA damage”</a:t>
            </a:r>
            <a:endParaRPr lang="en-AU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1231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bf74718-704d-415e-8c81-199debd1d983">
      <Terms xmlns="http://schemas.microsoft.com/office/infopath/2007/PartnerControls"/>
    </lcf76f155ced4ddcb4097134ff3c332f>
    <TaxCatchAll xmlns="16086451-6d37-4935-be9a-a54fea27915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939B9DE810C564BB10D5A05C9E40477" ma:contentTypeVersion="12" ma:contentTypeDescription="Create a new document." ma:contentTypeScope="" ma:versionID="6f7778fe5f87323c20948e62eaa931bb">
  <xsd:schema xmlns:xsd="http://www.w3.org/2001/XMLSchema" xmlns:xs="http://www.w3.org/2001/XMLSchema" xmlns:p="http://schemas.microsoft.com/office/2006/metadata/properties" xmlns:ns2="cbf74718-704d-415e-8c81-199debd1d983" xmlns:ns3="16086451-6d37-4935-be9a-a54fea279158" targetNamespace="http://schemas.microsoft.com/office/2006/metadata/properties" ma:root="true" ma:fieldsID="f2ae6248c8cc889fd35ff0e51eee6453" ns2:_="" ns3:_="">
    <xsd:import namespace="cbf74718-704d-415e-8c81-199debd1d983"/>
    <xsd:import namespace="16086451-6d37-4935-be9a-a54fea27915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f74718-704d-415e-8c81-199debd1d98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c9513c6f-d7d3-4bba-9430-ae338114780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086451-6d37-4935-be9a-a54fea279158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dd793f53-2cef-4168-a2be-3c208930e1ce}" ma:internalName="TaxCatchAll" ma:showField="CatchAllData" ma:web="16086451-6d37-4935-be9a-a54fea27915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28C5662-4CBD-43E9-96F7-C4ACC801D4A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B2F850C-E068-4305-BC7B-7B5F0480BB2A}">
  <ds:schemaRefs>
    <ds:schemaRef ds:uri="http://schemas.microsoft.com/office/2006/metadata/properties"/>
    <ds:schemaRef ds:uri="http://schemas.microsoft.com/office/infopath/2007/PartnerControls"/>
    <ds:schemaRef ds:uri="cbf74718-704d-415e-8c81-199debd1d983"/>
    <ds:schemaRef ds:uri="16086451-6d37-4935-be9a-a54fea279158"/>
  </ds:schemaRefs>
</ds:datastoreItem>
</file>

<file path=customXml/itemProps3.xml><?xml version="1.0" encoding="utf-8"?>
<ds:datastoreItem xmlns:ds="http://schemas.openxmlformats.org/officeDocument/2006/customXml" ds:itemID="{FF681781-9961-4FFA-9991-5C72E43DD68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bf74718-704d-415e-8c81-199debd1d983"/>
    <ds:schemaRef ds:uri="16086451-6d37-4935-be9a-a54fea27915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Bull</dc:creator>
  <cp:lastModifiedBy>Bull, Caroline (H&amp;B, Adelaide K. Ave)</cp:lastModifiedBy>
  <cp:revision>1</cp:revision>
  <dcterms:created xsi:type="dcterms:W3CDTF">2022-10-16T02:10:45Z</dcterms:created>
  <dcterms:modified xsi:type="dcterms:W3CDTF">2023-06-08T00:2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939B9DE810C564BB10D5A05C9E40477</vt:lpwstr>
  </property>
  <property fmtid="{D5CDD505-2E9C-101B-9397-08002B2CF9AE}" pid="3" name="MediaServiceImageTags">
    <vt:lpwstr/>
  </property>
</Properties>
</file>